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430" r:id="rId2"/>
    <p:sldId id="432" r:id="rId3"/>
    <p:sldId id="431" r:id="rId4"/>
    <p:sldId id="434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2A1A1"/>
    <a:srgbClr val="9DC3E6"/>
    <a:srgbClr val="CBA9E5"/>
    <a:srgbClr val="AE78D6"/>
    <a:srgbClr val="8BB8E1"/>
    <a:srgbClr val="FF4343"/>
    <a:srgbClr val="F3F2F1"/>
    <a:srgbClr val="FF5D5D"/>
    <a:srgbClr val="9F9A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214" autoAdjust="0"/>
  </p:normalViewPr>
  <p:slideViewPr>
    <p:cSldViewPr snapToGrid="0">
      <p:cViewPr varScale="1">
        <p:scale>
          <a:sx n="46" d="100"/>
          <a:sy n="46" d="100"/>
        </p:scale>
        <p:origin x="1770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5120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0206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5453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7302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9574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6401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1751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6905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7815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9864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7270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E1D736-5092-4AAC-9DC7-4081CD8C4C1D}" type="datetimeFigureOut">
              <a:rPr lang="zh-CN" altLang="en-US" smtClean="0"/>
              <a:t>2024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6B1007-C2AF-4140-82FA-5F055085BB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6223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g"/><Relationship Id="rId13" Type="http://schemas.openxmlformats.org/officeDocument/2006/relationships/image" Target="../media/image19.jpg"/><Relationship Id="rId3" Type="http://schemas.openxmlformats.org/officeDocument/2006/relationships/image" Target="../media/image9.jpg"/><Relationship Id="rId7" Type="http://schemas.openxmlformats.org/officeDocument/2006/relationships/image" Target="../media/image13.jpg"/><Relationship Id="rId12" Type="http://schemas.openxmlformats.org/officeDocument/2006/relationships/image" Target="../media/image18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g"/><Relationship Id="rId11" Type="http://schemas.openxmlformats.org/officeDocument/2006/relationships/image" Target="../media/image17.jpg"/><Relationship Id="rId5" Type="http://schemas.openxmlformats.org/officeDocument/2006/relationships/image" Target="../media/image11.png"/><Relationship Id="rId10" Type="http://schemas.openxmlformats.org/officeDocument/2006/relationships/image" Target="../media/image16.jpg"/><Relationship Id="rId4" Type="http://schemas.openxmlformats.org/officeDocument/2006/relationships/image" Target="../media/image10.jpg"/><Relationship Id="rId9" Type="http://schemas.openxmlformats.org/officeDocument/2006/relationships/image" Target="../media/image15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1F99444-1B27-9087-8BA8-14CA8E8966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3079" y="5284139"/>
            <a:ext cx="3028119" cy="73219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3EA60C2-4CAC-465E-6D84-DD005B0D6FE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741" t="13839" r="3909" b="18005"/>
          <a:stretch/>
        </p:blipFill>
        <p:spPr>
          <a:xfrm>
            <a:off x="1803079" y="4356749"/>
            <a:ext cx="3028120" cy="705737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A5E79ADC-4F72-1275-61B6-6FFD663CDF2F}"/>
              </a:ext>
            </a:extLst>
          </p:cNvPr>
          <p:cNvSpPr/>
          <p:nvPr/>
        </p:nvSpPr>
        <p:spPr>
          <a:xfrm>
            <a:off x="2901702" y="4526737"/>
            <a:ext cx="1482588" cy="32464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61DCB41D-1B6E-52AB-8762-3E0B267A5247}"/>
              </a:ext>
            </a:extLst>
          </p:cNvPr>
          <p:cNvSpPr/>
          <p:nvPr/>
        </p:nvSpPr>
        <p:spPr>
          <a:xfrm>
            <a:off x="3006476" y="5600085"/>
            <a:ext cx="1377814" cy="5315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F92B03AD-E996-9ED0-F0BA-685CEC9CDD77}"/>
              </a:ext>
            </a:extLst>
          </p:cNvPr>
          <p:cNvSpPr txBox="1"/>
          <p:nvPr/>
        </p:nvSpPr>
        <p:spPr>
          <a:xfrm>
            <a:off x="964324" y="5435022"/>
            <a:ext cx="838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096716EA-D131-F5B3-D2D3-EC1BFCB71B47}"/>
              </a:ext>
            </a:extLst>
          </p:cNvPr>
          <p:cNvSpPr txBox="1"/>
          <p:nvPr/>
        </p:nvSpPr>
        <p:spPr>
          <a:xfrm>
            <a:off x="763097" y="914925"/>
            <a:ext cx="10336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MBRA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6416384C-91A9-E668-3CDC-D17822FA7721}"/>
              </a:ext>
            </a:extLst>
          </p:cNvPr>
          <p:cNvSpPr/>
          <p:nvPr/>
        </p:nvSpPr>
        <p:spPr>
          <a:xfrm>
            <a:off x="126096" y="3970649"/>
            <a:ext cx="6542116" cy="2236881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4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0C66EF63-6A38-CA6C-F1B8-23991ADB03E1}"/>
              </a:ext>
            </a:extLst>
          </p:cNvPr>
          <p:cNvSpPr txBox="1"/>
          <p:nvPr/>
        </p:nvSpPr>
        <p:spPr>
          <a:xfrm>
            <a:off x="93562" y="3547596"/>
            <a:ext cx="1895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.2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6D078995-0CCD-B7B8-1F7E-61BCA887734C}"/>
              </a:ext>
            </a:extLst>
          </p:cNvPr>
          <p:cNvSpPr/>
          <p:nvPr/>
        </p:nvSpPr>
        <p:spPr>
          <a:xfrm>
            <a:off x="93562" y="720730"/>
            <a:ext cx="6542116" cy="1510144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4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FA0A85D-95A8-7A45-C330-718AF6443AE0}"/>
              </a:ext>
            </a:extLst>
          </p:cNvPr>
          <p:cNvSpPr txBox="1"/>
          <p:nvPr/>
        </p:nvSpPr>
        <p:spPr>
          <a:xfrm>
            <a:off x="-6288" y="361926"/>
            <a:ext cx="1895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. 2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83BE5671-154A-26D0-58C8-B5BE3538F97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601" b="34242"/>
          <a:stretch/>
        </p:blipFill>
        <p:spPr>
          <a:xfrm>
            <a:off x="1780118" y="776314"/>
            <a:ext cx="3028119" cy="83929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A3DBEECA-3294-56E8-4454-69B3E9FABD1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355" b="54350"/>
          <a:stretch/>
        </p:blipFill>
        <p:spPr>
          <a:xfrm>
            <a:off x="1780118" y="1689283"/>
            <a:ext cx="3027070" cy="386860"/>
          </a:xfrm>
          <a:prstGeom prst="rect">
            <a:avLst/>
          </a:prstGeom>
        </p:spPr>
      </p:pic>
      <p:sp>
        <p:nvSpPr>
          <p:cNvPr id="25" name="矩形 24">
            <a:extLst>
              <a:ext uri="{FF2B5EF4-FFF2-40B4-BE49-F238E27FC236}">
                <a16:creationId xmlns:a16="http://schemas.microsoft.com/office/drawing/2014/main" id="{9343718A-D572-6E96-D244-562B95FD1658}"/>
              </a:ext>
            </a:extLst>
          </p:cNvPr>
          <p:cNvSpPr/>
          <p:nvPr/>
        </p:nvSpPr>
        <p:spPr>
          <a:xfrm>
            <a:off x="2290338" y="1130056"/>
            <a:ext cx="588404" cy="2751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EC150EF4-EA49-C332-237B-DD0EC820A4AE}"/>
              </a:ext>
            </a:extLst>
          </p:cNvPr>
          <p:cNvSpPr/>
          <p:nvPr/>
        </p:nvSpPr>
        <p:spPr>
          <a:xfrm>
            <a:off x="2353836" y="1799859"/>
            <a:ext cx="629679" cy="2018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EF179A2-3AFC-49A2-18F0-A97D0665EB17}"/>
              </a:ext>
            </a:extLst>
          </p:cNvPr>
          <p:cNvSpPr txBox="1"/>
          <p:nvPr/>
        </p:nvSpPr>
        <p:spPr>
          <a:xfrm>
            <a:off x="801911" y="4543607"/>
            <a:ext cx="10336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MBRA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E220A9A-2925-E04B-C4AC-3BF662E66736}"/>
              </a:ext>
            </a:extLst>
          </p:cNvPr>
          <p:cNvSpPr txBox="1"/>
          <p:nvPr/>
        </p:nvSpPr>
        <p:spPr>
          <a:xfrm>
            <a:off x="893462" y="1589847"/>
            <a:ext cx="886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91234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FADF7C64-9DFE-4DC8-DF76-DEA05640A59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179" b="49177"/>
          <a:stretch/>
        </p:blipFill>
        <p:spPr>
          <a:xfrm>
            <a:off x="1844498" y="1817444"/>
            <a:ext cx="2981992" cy="682427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0A11651-725D-22C3-6ABB-5AB015ABF9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4498" y="1138367"/>
            <a:ext cx="2981993" cy="45412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50ADE354-969B-8C68-77F1-85687BC194A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762" b="35646"/>
          <a:stretch/>
        </p:blipFill>
        <p:spPr>
          <a:xfrm>
            <a:off x="1844498" y="2692070"/>
            <a:ext cx="2981992" cy="475290"/>
          </a:xfrm>
          <a:prstGeom prst="rect">
            <a:avLst/>
          </a:prstGeom>
        </p:spPr>
      </p:pic>
      <p:sp>
        <p:nvSpPr>
          <p:cNvPr id="37" name="矩形 36">
            <a:extLst>
              <a:ext uri="{FF2B5EF4-FFF2-40B4-BE49-F238E27FC236}">
                <a16:creationId xmlns:a16="http://schemas.microsoft.com/office/drawing/2014/main" id="{45FEF163-7F69-5F7F-0716-FCD89C43DA0D}"/>
              </a:ext>
            </a:extLst>
          </p:cNvPr>
          <p:cNvSpPr/>
          <p:nvPr/>
        </p:nvSpPr>
        <p:spPr>
          <a:xfrm>
            <a:off x="2379173" y="2724828"/>
            <a:ext cx="1645574" cy="3484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FDC4596C-E727-733B-FC00-4C3700067011}"/>
              </a:ext>
            </a:extLst>
          </p:cNvPr>
          <p:cNvSpPr/>
          <p:nvPr/>
        </p:nvSpPr>
        <p:spPr>
          <a:xfrm>
            <a:off x="2372669" y="2093634"/>
            <a:ext cx="1645574" cy="3484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9FB138F0-6FC1-32B6-5FD5-EE3228D729E9}"/>
              </a:ext>
            </a:extLst>
          </p:cNvPr>
          <p:cNvSpPr/>
          <p:nvPr/>
        </p:nvSpPr>
        <p:spPr>
          <a:xfrm>
            <a:off x="2338728" y="1156213"/>
            <a:ext cx="1645574" cy="3484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315BC996-6521-88C0-F798-9F18FCC0B809}"/>
              </a:ext>
            </a:extLst>
          </p:cNvPr>
          <p:cNvSpPr txBox="1"/>
          <p:nvPr/>
        </p:nvSpPr>
        <p:spPr>
          <a:xfrm>
            <a:off x="996630" y="2068861"/>
            <a:ext cx="11012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yclinD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26E260DF-CC87-5FEA-E218-3CBD921A7954}"/>
              </a:ext>
            </a:extLst>
          </p:cNvPr>
          <p:cNvSpPr txBox="1"/>
          <p:nvPr/>
        </p:nvSpPr>
        <p:spPr>
          <a:xfrm>
            <a:off x="831512" y="1213914"/>
            <a:ext cx="12729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-CyclinD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FFD805BB-74C5-E850-F3BE-D9CFC5FF340D}"/>
              </a:ext>
            </a:extLst>
          </p:cNvPr>
          <p:cNvSpPr txBox="1"/>
          <p:nvPr/>
        </p:nvSpPr>
        <p:spPr>
          <a:xfrm>
            <a:off x="1089547" y="2702401"/>
            <a:ext cx="886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2A7B899E-85E2-1B53-CC7E-866BA3F85BC3}"/>
              </a:ext>
            </a:extLst>
          </p:cNvPr>
          <p:cNvSpPr txBox="1"/>
          <p:nvPr/>
        </p:nvSpPr>
        <p:spPr>
          <a:xfrm>
            <a:off x="195786" y="474188"/>
            <a:ext cx="1895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 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AD488968-BE09-DBDB-5A5A-9801DCECE9B9}"/>
              </a:ext>
            </a:extLst>
          </p:cNvPr>
          <p:cNvSpPr/>
          <p:nvPr/>
        </p:nvSpPr>
        <p:spPr>
          <a:xfrm>
            <a:off x="157942" y="409591"/>
            <a:ext cx="6542116" cy="3579934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4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78757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B44E0E74-CEB3-3F24-03FA-8BFB4B9CCF3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02" t="68629" r="5499" b="8045"/>
          <a:stretch/>
        </p:blipFill>
        <p:spPr>
          <a:xfrm>
            <a:off x="1798006" y="7468654"/>
            <a:ext cx="3018071" cy="61388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08F84CE-BE52-0F69-5C3F-CD727682B72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50" t="46927" b="44253"/>
          <a:stretch/>
        </p:blipFill>
        <p:spPr>
          <a:xfrm>
            <a:off x="1798006" y="8218926"/>
            <a:ext cx="2960001" cy="422079"/>
          </a:xfrm>
          <a:prstGeom prst="rect">
            <a:avLst/>
          </a:prstGeom>
        </p:spPr>
      </p:pic>
      <p:pic>
        <p:nvPicPr>
          <p:cNvPr id="11" name="内容占位符 10">
            <a:extLst>
              <a:ext uri="{FF2B5EF4-FFF2-40B4-BE49-F238E27FC236}">
                <a16:creationId xmlns:a16="http://schemas.microsoft.com/office/drawing/2014/main" id="{A90CAFDD-83B6-F4C8-E32A-3138D373B28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588" b="27989"/>
          <a:stretch/>
        </p:blipFill>
        <p:spPr>
          <a:xfrm>
            <a:off x="1834085" y="1916172"/>
            <a:ext cx="2981992" cy="714375"/>
          </a:xfr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C213B58-9510-967D-17B4-0D7D46920F8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8007" y="3988885"/>
            <a:ext cx="3054148" cy="36164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325EF5F-98EA-7430-97C0-1FE296EE109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199" b="41347"/>
          <a:stretch/>
        </p:blipFill>
        <p:spPr>
          <a:xfrm>
            <a:off x="1834085" y="5541358"/>
            <a:ext cx="2981992" cy="428625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E10AFD6E-0849-FCD0-1956-7AD87E803C4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35" t="21070" r="1135" b="55276"/>
          <a:stretch/>
        </p:blipFill>
        <p:spPr>
          <a:xfrm>
            <a:off x="1824370" y="2803505"/>
            <a:ext cx="2981992" cy="969916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56A14284-3436-69DC-EF21-7FB06C661DE2}"/>
              </a:ext>
            </a:extLst>
          </p:cNvPr>
          <p:cNvSpPr txBox="1"/>
          <p:nvPr/>
        </p:nvSpPr>
        <p:spPr>
          <a:xfrm>
            <a:off x="669262" y="2798052"/>
            <a:ext cx="10336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leave caspase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50AF3CB-419E-570B-8E25-A6B582DDB12E}"/>
              </a:ext>
            </a:extLst>
          </p:cNvPr>
          <p:cNvSpPr txBox="1"/>
          <p:nvPr/>
        </p:nvSpPr>
        <p:spPr>
          <a:xfrm>
            <a:off x="669261" y="3953822"/>
            <a:ext cx="10336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64CC36D7-7B2B-D982-B9C4-A9FBECDD8D6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467" b="51484"/>
          <a:stretch/>
        </p:blipFill>
        <p:spPr>
          <a:xfrm>
            <a:off x="1834085" y="4509347"/>
            <a:ext cx="2981992" cy="863033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5C33D188-5922-10A3-8EEF-91350102BD9D}"/>
              </a:ext>
            </a:extLst>
          </p:cNvPr>
          <p:cNvSpPr txBox="1"/>
          <p:nvPr/>
        </p:nvSpPr>
        <p:spPr>
          <a:xfrm>
            <a:off x="601669" y="4756197"/>
            <a:ext cx="11012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8BD667F-188E-FFC6-16B7-368ED0C047E5}"/>
              </a:ext>
            </a:extLst>
          </p:cNvPr>
          <p:cNvSpPr txBox="1"/>
          <p:nvPr/>
        </p:nvSpPr>
        <p:spPr>
          <a:xfrm>
            <a:off x="921278" y="7581518"/>
            <a:ext cx="7816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DB1	                   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F9D185C9-77FD-1038-BB4D-431D17742CE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366" b="58709"/>
          <a:stretch/>
        </p:blipFill>
        <p:spPr>
          <a:xfrm>
            <a:off x="1787379" y="8846654"/>
            <a:ext cx="2981992" cy="488989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49A2C4B9-711D-0499-2E55-A8EEBC1A390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485" b="55009"/>
          <a:stretch/>
        </p:blipFill>
        <p:spPr>
          <a:xfrm rot="10800000">
            <a:off x="1834085" y="745718"/>
            <a:ext cx="2981992" cy="1127824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2EC863BA-5FE4-D016-E408-D215820F7D4C}"/>
              </a:ext>
            </a:extLst>
          </p:cNvPr>
          <p:cNvSpPr txBox="1"/>
          <p:nvPr/>
        </p:nvSpPr>
        <p:spPr>
          <a:xfrm>
            <a:off x="2300382" y="1230291"/>
            <a:ext cx="166449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4283F9B-9D7B-E205-7A75-8DA31179684E}"/>
              </a:ext>
            </a:extLst>
          </p:cNvPr>
          <p:cNvSpPr txBox="1"/>
          <p:nvPr/>
        </p:nvSpPr>
        <p:spPr>
          <a:xfrm>
            <a:off x="956834" y="2043634"/>
            <a:ext cx="7460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E243D7F-F841-76ED-3DE1-411E1A2F1A6D}"/>
              </a:ext>
            </a:extLst>
          </p:cNvPr>
          <p:cNvSpPr txBox="1"/>
          <p:nvPr/>
        </p:nvSpPr>
        <p:spPr>
          <a:xfrm>
            <a:off x="886589" y="1100474"/>
            <a:ext cx="8163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γH2AX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32A9BD3-D4D2-A451-70B2-70A95EC488F4}"/>
              </a:ext>
            </a:extLst>
          </p:cNvPr>
          <p:cNvSpPr txBox="1"/>
          <p:nvPr/>
        </p:nvSpPr>
        <p:spPr>
          <a:xfrm>
            <a:off x="2300382" y="2075844"/>
            <a:ext cx="166449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04DDC06-B834-3C08-0C52-62429DFB996E}"/>
              </a:ext>
            </a:extLst>
          </p:cNvPr>
          <p:cNvSpPr txBox="1"/>
          <p:nvPr/>
        </p:nvSpPr>
        <p:spPr>
          <a:xfrm>
            <a:off x="2300382" y="2955383"/>
            <a:ext cx="166449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990B10A-5333-E104-3901-930D879EEC50}"/>
              </a:ext>
            </a:extLst>
          </p:cNvPr>
          <p:cNvSpPr txBox="1"/>
          <p:nvPr/>
        </p:nvSpPr>
        <p:spPr>
          <a:xfrm>
            <a:off x="2311527" y="3995700"/>
            <a:ext cx="166449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EC2D972-BED7-BD47-4224-411244F5D45A}"/>
              </a:ext>
            </a:extLst>
          </p:cNvPr>
          <p:cNvSpPr txBox="1"/>
          <p:nvPr/>
        </p:nvSpPr>
        <p:spPr>
          <a:xfrm>
            <a:off x="2368677" y="4579537"/>
            <a:ext cx="166449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03A9972-3080-0933-A4F6-40DEB1CC8A67}"/>
              </a:ext>
            </a:extLst>
          </p:cNvPr>
          <p:cNvSpPr txBox="1"/>
          <p:nvPr/>
        </p:nvSpPr>
        <p:spPr>
          <a:xfrm>
            <a:off x="816259" y="5571004"/>
            <a:ext cx="886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B6DD57E3-F449-09D9-A95C-CF2D0E0E2394}"/>
              </a:ext>
            </a:extLst>
          </p:cNvPr>
          <p:cNvSpPr txBox="1"/>
          <p:nvPr/>
        </p:nvSpPr>
        <p:spPr>
          <a:xfrm>
            <a:off x="2052393" y="5523450"/>
            <a:ext cx="166449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246001B7-A9F4-CBED-60F9-6E970EB26892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153" b="39065"/>
          <a:stretch/>
        </p:blipFill>
        <p:spPr>
          <a:xfrm>
            <a:off x="1787379" y="10291486"/>
            <a:ext cx="2981992" cy="852125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E9EBFC0F-BBDB-1177-998D-13893E8CB8CF}"/>
              </a:ext>
            </a:extLst>
          </p:cNvPr>
          <p:cNvSpPr txBox="1"/>
          <p:nvPr/>
        </p:nvSpPr>
        <p:spPr>
          <a:xfrm>
            <a:off x="758722" y="8290629"/>
            <a:ext cx="94419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XO3A	                   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F745CE17-BE69-C7FF-6AEC-2C44F3F0B551}"/>
              </a:ext>
            </a:extLst>
          </p:cNvPr>
          <p:cNvSpPr txBox="1"/>
          <p:nvPr/>
        </p:nvSpPr>
        <p:spPr>
          <a:xfrm>
            <a:off x="787835" y="10421762"/>
            <a:ext cx="10101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KN1B</a:t>
            </a: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	                   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903AAAEB-8AF0-02D6-9490-30FF9B781CBC}"/>
              </a:ext>
            </a:extLst>
          </p:cNvPr>
          <p:cNvSpPr txBox="1"/>
          <p:nvPr/>
        </p:nvSpPr>
        <p:spPr>
          <a:xfrm>
            <a:off x="1077015" y="8914490"/>
            <a:ext cx="5791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53	                   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FE50EDA3-5502-33B8-9604-C73853704D3E}"/>
              </a:ext>
            </a:extLst>
          </p:cNvPr>
          <p:cNvSpPr txBox="1"/>
          <p:nvPr/>
        </p:nvSpPr>
        <p:spPr>
          <a:xfrm>
            <a:off x="2368604" y="7526407"/>
            <a:ext cx="1596272" cy="4279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D46CD47C-D0D0-8E20-33BB-7D38BED46851}"/>
              </a:ext>
            </a:extLst>
          </p:cNvPr>
          <p:cNvSpPr txBox="1"/>
          <p:nvPr/>
        </p:nvSpPr>
        <p:spPr>
          <a:xfrm>
            <a:off x="2264821" y="8983285"/>
            <a:ext cx="166449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899DB48-916C-9869-8C2D-4A6DBE85C366}"/>
              </a:ext>
            </a:extLst>
          </p:cNvPr>
          <p:cNvSpPr txBox="1"/>
          <p:nvPr/>
        </p:nvSpPr>
        <p:spPr>
          <a:xfrm>
            <a:off x="2306290" y="10354355"/>
            <a:ext cx="166449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DE6EE6E8-A59B-EBB3-88A2-3DFEF8C2A3F9}"/>
              </a:ext>
            </a:extLst>
          </p:cNvPr>
          <p:cNvSpPr txBox="1"/>
          <p:nvPr/>
        </p:nvSpPr>
        <p:spPr>
          <a:xfrm>
            <a:off x="311936" y="248057"/>
            <a:ext cx="1895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091A43C7-FE95-445A-C2A2-AE231518F2DB}"/>
              </a:ext>
            </a:extLst>
          </p:cNvPr>
          <p:cNvSpPr/>
          <p:nvPr/>
        </p:nvSpPr>
        <p:spPr>
          <a:xfrm>
            <a:off x="157942" y="628894"/>
            <a:ext cx="6542116" cy="5502228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4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A820ECF1-D87E-EEA7-F23C-A09EA331030E}"/>
              </a:ext>
            </a:extLst>
          </p:cNvPr>
          <p:cNvSpPr/>
          <p:nvPr/>
        </p:nvSpPr>
        <p:spPr>
          <a:xfrm>
            <a:off x="157942" y="6131122"/>
            <a:ext cx="6542116" cy="6060878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4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E0B47A0B-EED2-AE10-CF80-3091F22C1D5C}"/>
              </a:ext>
            </a:extLst>
          </p:cNvPr>
          <p:cNvSpPr txBox="1"/>
          <p:nvPr/>
        </p:nvSpPr>
        <p:spPr>
          <a:xfrm>
            <a:off x="165965" y="6762662"/>
            <a:ext cx="1895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C16B72F-356F-21AF-0218-5F6A249CCF3E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660" b="47182"/>
          <a:stretch/>
        </p:blipFill>
        <p:spPr>
          <a:xfrm>
            <a:off x="1751300" y="9569361"/>
            <a:ext cx="2981992" cy="45752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3E0EA4F-1E60-F96C-FE40-3EE13CD157F6}"/>
              </a:ext>
            </a:extLst>
          </p:cNvPr>
          <p:cNvSpPr txBox="1"/>
          <p:nvPr/>
        </p:nvSpPr>
        <p:spPr>
          <a:xfrm>
            <a:off x="1097329" y="9682057"/>
            <a:ext cx="5791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RK	                   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11D6C9E-CFE7-1B5E-1D0A-BCDEA2D7A3E4}"/>
              </a:ext>
            </a:extLst>
          </p:cNvPr>
          <p:cNvSpPr txBox="1"/>
          <p:nvPr/>
        </p:nvSpPr>
        <p:spPr>
          <a:xfrm>
            <a:off x="2321971" y="9633437"/>
            <a:ext cx="166449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3BBA677B-F9D8-E58F-4EDE-959432285D87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309" b="55776"/>
          <a:stretch/>
        </p:blipFill>
        <p:spPr>
          <a:xfrm>
            <a:off x="1816044" y="11285227"/>
            <a:ext cx="2990317" cy="489905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81869F34-058B-3DC9-E57A-AEB71E5C6D9F}"/>
              </a:ext>
            </a:extLst>
          </p:cNvPr>
          <p:cNvSpPr txBox="1"/>
          <p:nvPr/>
        </p:nvSpPr>
        <p:spPr>
          <a:xfrm>
            <a:off x="868768" y="11424083"/>
            <a:ext cx="886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253C838-0BF9-974A-30C0-EC0B3F43F9DF}"/>
              </a:ext>
            </a:extLst>
          </p:cNvPr>
          <p:cNvSpPr txBox="1"/>
          <p:nvPr/>
        </p:nvSpPr>
        <p:spPr>
          <a:xfrm>
            <a:off x="2880196" y="8384233"/>
            <a:ext cx="1818804" cy="42207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27833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男人, 卡车, 覆盖, 厨房&#10;&#10;描述已自动生成">
            <a:extLst>
              <a:ext uri="{FF2B5EF4-FFF2-40B4-BE49-F238E27FC236}">
                <a16:creationId xmlns:a16="http://schemas.microsoft.com/office/drawing/2014/main" id="{173BA90B-632A-3C50-F8AC-BCE2499B761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042" b="42955"/>
          <a:stretch/>
        </p:blipFill>
        <p:spPr>
          <a:xfrm>
            <a:off x="1744259" y="3139794"/>
            <a:ext cx="2981992" cy="57415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FECAE8B-0489-BF9A-9DA9-8DB059E24679}"/>
              </a:ext>
            </a:extLst>
          </p:cNvPr>
          <p:cNvSpPr txBox="1"/>
          <p:nvPr/>
        </p:nvSpPr>
        <p:spPr>
          <a:xfrm>
            <a:off x="785411" y="3255264"/>
            <a:ext cx="886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 descr="白板&#10;&#10;描述已自动生成">
            <a:extLst>
              <a:ext uri="{FF2B5EF4-FFF2-40B4-BE49-F238E27FC236}">
                <a16:creationId xmlns:a16="http://schemas.microsoft.com/office/drawing/2014/main" id="{89C57C74-1D74-A694-0B47-694817C3995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599" b="29212"/>
          <a:stretch/>
        </p:blipFill>
        <p:spPr>
          <a:xfrm>
            <a:off x="1834637" y="2039608"/>
            <a:ext cx="2981992" cy="78681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AFB44E76-B994-DC36-8634-1E6B06DFD894}"/>
              </a:ext>
            </a:extLst>
          </p:cNvPr>
          <p:cNvSpPr txBox="1"/>
          <p:nvPr/>
        </p:nvSpPr>
        <p:spPr>
          <a:xfrm>
            <a:off x="437047" y="1610762"/>
            <a:ext cx="1895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.S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484E85B-87F0-B64E-A25C-122890C15A3D}"/>
              </a:ext>
            </a:extLst>
          </p:cNvPr>
          <p:cNvSpPr txBox="1"/>
          <p:nvPr/>
        </p:nvSpPr>
        <p:spPr>
          <a:xfrm>
            <a:off x="724416" y="2433013"/>
            <a:ext cx="1895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MBRA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A1E9B566-D4E1-B6AA-D774-476D5DC7D2F6}"/>
              </a:ext>
            </a:extLst>
          </p:cNvPr>
          <p:cNvSpPr/>
          <p:nvPr/>
        </p:nvSpPr>
        <p:spPr>
          <a:xfrm>
            <a:off x="2895015" y="2433013"/>
            <a:ext cx="484544" cy="2200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E6F1A070-5D02-1D4E-D6F3-2B6D1FA31057}"/>
              </a:ext>
            </a:extLst>
          </p:cNvPr>
          <p:cNvSpPr/>
          <p:nvPr/>
        </p:nvSpPr>
        <p:spPr>
          <a:xfrm>
            <a:off x="3036782" y="3234858"/>
            <a:ext cx="484544" cy="2200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D05AE468-8574-E050-A4ED-E593BDDB34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4521" y="6879495"/>
            <a:ext cx="4238625" cy="101917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9F54C03-D1D8-1377-8AA3-CB5370A76E8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64521" y="8115675"/>
            <a:ext cx="4238625" cy="729645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CA5DC096-3825-ED99-F8A5-8FE20A59C681}"/>
              </a:ext>
            </a:extLst>
          </p:cNvPr>
          <p:cNvSpPr txBox="1"/>
          <p:nvPr/>
        </p:nvSpPr>
        <p:spPr>
          <a:xfrm>
            <a:off x="1129622" y="7407896"/>
            <a:ext cx="11012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MBRA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AEA6279-C845-164B-2E61-A86C4B16C455}"/>
              </a:ext>
            </a:extLst>
          </p:cNvPr>
          <p:cNvSpPr txBox="1"/>
          <p:nvPr/>
        </p:nvSpPr>
        <p:spPr>
          <a:xfrm>
            <a:off x="1236917" y="8172721"/>
            <a:ext cx="886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8016C6A2-5D48-9F4C-741C-BBA0E0A04F16}"/>
              </a:ext>
            </a:extLst>
          </p:cNvPr>
          <p:cNvSpPr/>
          <p:nvPr/>
        </p:nvSpPr>
        <p:spPr>
          <a:xfrm>
            <a:off x="102283" y="5849837"/>
            <a:ext cx="6542116" cy="3579934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4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EEACF86C-6CF2-0A5A-55FA-3FF3A9431C41}"/>
              </a:ext>
            </a:extLst>
          </p:cNvPr>
          <p:cNvSpPr/>
          <p:nvPr/>
        </p:nvSpPr>
        <p:spPr>
          <a:xfrm>
            <a:off x="3871553" y="7258670"/>
            <a:ext cx="653184" cy="3780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829EE0EF-9EFC-D9B2-59F9-F81C2393AC2C}"/>
              </a:ext>
            </a:extLst>
          </p:cNvPr>
          <p:cNvSpPr/>
          <p:nvPr/>
        </p:nvSpPr>
        <p:spPr>
          <a:xfrm>
            <a:off x="3530335" y="8277845"/>
            <a:ext cx="633024" cy="2611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2BA4F80-4081-0C0D-E90D-4039D5FEC4D9}"/>
              </a:ext>
            </a:extLst>
          </p:cNvPr>
          <p:cNvSpPr txBox="1"/>
          <p:nvPr/>
        </p:nvSpPr>
        <p:spPr>
          <a:xfrm>
            <a:off x="228271" y="5359063"/>
            <a:ext cx="18953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.S5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8F0B833F-1559-E6FF-C4FC-86D0355CF495}"/>
              </a:ext>
            </a:extLst>
          </p:cNvPr>
          <p:cNvSpPr/>
          <p:nvPr/>
        </p:nvSpPr>
        <p:spPr>
          <a:xfrm>
            <a:off x="157942" y="863105"/>
            <a:ext cx="6542116" cy="3579934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 sz="1400">
              <a:noFill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0900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709</TotalTime>
  <Words>53</Words>
  <Application>Microsoft Office PowerPoint</Application>
  <PresentationFormat>宽屏</PresentationFormat>
  <Paragraphs>31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haijing zhong</cp:lastModifiedBy>
  <cp:revision>24</cp:revision>
  <dcterms:created xsi:type="dcterms:W3CDTF">2023-11-09T14:05:38Z</dcterms:created>
  <dcterms:modified xsi:type="dcterms:W3CDTF">2024-11-28T07:00:31Z</dcterms:modified>
</cp:coreProperties>
</file>